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2" r:id="rId3"/>
    <p:sldId id="269" r:id="rId4"/>
    <p:sldId id="268" r:id="rId5"/>
    <p:sldId id="264" r:id="rId6"/>
    <p:sldId id="271" r:id="rId7"/>
    <p:sldId id="266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4660"/>
  </p:normalViewPr>
  <p:slideViewPr>
    <p:cSldViewPr snapToGrid="0">
      <p:cViewPr varScale="1">
        <p:scale>
          <a:sx n="55" d="100"/>
          <a:sy n="55" d="100"/>
        </p:scale>
        <p:origin x="225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251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541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678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44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253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174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601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436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4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055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509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D34C4-73D3-457B-A6E1-64E259B23391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62FEE-D004-40A2-B171-2D1A19EF86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384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image" Target="../media/image9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531" y="992998"/>
            <a:ext cx="6456063" cy="4519244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40939541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58485" y="1161171"/>
            <a:ext cx="2330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NA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713201" y="1345837"/>
            <a:ext cx="1004119" cy="1477328"/>
            <a:chOff x="10914290" y="322294"/>
            <a:chExt cx="1004119" cy="1477328"/>
          </a:xfrm>
        </p:grpSpPr>
        <p:grpSp>
          <p:nvGrpSpPr>
            <p:cNvPr id="7" name="Group 6"/>
            <p:cNvGrpSpPr/>
            <p:nvPr/>
          </p:nvGrpSpPr>
          <p:grpSpPr>
            <a:xfrm>
              <a:off x="10999617" y="546386"/>
              <a:ext cx="100627" cy="395712"/>
              <a:chOff x="5802630" y="182880"/>
              <a:chExt cx="232681" cy="915013"/>
            </a:xfrm>
          </p:grpSpPr>
          <p:sp>
            <p:nvSpPr>
              <p:cNvPr id="12" name="Oval 11"/>
              <p:cNvSpPr/>
              <p:nvPr/>
            </p:nvSpPr>
            <p:spPr>
              <a:xfrm>
                <a:off x="5806711" y="182880"/>
                <a:ext cx="228600" cy="228600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Isosceles Triangle 12"/>
              <p:cNvSpPr/>
              <p:nvPr/>
            </p:nvSpPr>
            <p:spPr>
              <a:xfrm>
                <a:off x="5802630" y="510984"/>
                <a:ext cx="228600" cy="228600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5806712" y="869293"/>
                <a:ext cx="224518" cy="22860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10914290" y="322294"/>
              <a:ext cx="1004119" cy="14773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Site</a:t>
              </a:r>
            </a:p>
            <a:p>
              <a:r>
                <a:rPr lang="en-US" sz="1000" dirty="0"/>
                <a:t>     Endometrial</a:t>
              </a:r>
            </a:p>
            <a:p>
              <a:r>
                <a:rPr lang="en-US" sz="1000" dirty="0"/>
                <a:t>     Ovarian</a:t>
              </a:r>
            </a:p>
            <a:p>
              <a:r>
                <a:rPr lang="en-US" sz="1000" dirty="0"/>
                <a:t>     TNBC</a:t>
              </a:r>
            </a:p>
            <a:p>
              <a:endParaRPr lang="en-US" sz="1000" dirty="0"/>
            </a:p>
            <a:p>
              <a:r>
                <a:rPr lang="en-US" sz="1000" b="1" dirty="0"/>
                <a:t>Outcome</a:t>
              </a:r>
            </a:p>
            <a:p>
              <a:r>
                <a:rPr lang="en-US" sz="1000" dirty="0"/>
                <a:t>     PR</a:t>
              </a:r>
            </a:p>
            <a:p>
              <a:r>
                <a:rPr lang="en-US" sz="1000" dirty="0"/>
                <a:t>     SD</a:t>
              </a:r>
            </a:p>
            <a:p>
              <a:r>
                <a:rPr lang="en-US" sz="1000" dirty="0"/>
                <a:t>     PD</a:t>
              </a:r>
            </a:p>
          </p:txBody>
        </p:sp>
        <p:sp>
          <p:nvSpPr>
            <p:cNvPr id="9" name="Oval 8"/>
            <p:cNvSpPr/>
            <p:nvPr/>
          </p:nvSpPr>
          <p:spPr>
            <a:xfrm>
              <a:off x="11010429" y="1317277"/>
              <a:ext cx="98862" cy="98862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6">
                <a:shade val="50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Oval 9"/>
            <p:cNvSpPr/>
            <p:nvPr/>
          </p:nvSpPr>
          <p:spPr>
            <a:xfrm>
              <a:off x="11010429" y="1469676"/>
              <a:ext cx="98862" cy="98862"/>
            </a:xfrm>
            <a:prstGeom prst="ellipse">
              <a:avLst/>
            </a:prstGeom>
            <a:solidFill>
              <a:schemeClr val="accent5"/>
            </a:solidFill>
            <a:ln>
              <a:solidFill>
                <a:schemeClr val="accent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Oval 10"/>
            <p:cNvSpPr/>
            <p:nvPr/>
          </p:nvSpPr>
          <p:spPr>
            <a:xfrm>
              <a:off x="11010429" y="1613763"/>
              <a:ext cx="98862" cy="98862"/>
            </a:xfrm>
            <a:prstGeom prst="ellipse">
              <a:avLst/>
            </a:prstGeom>
            <a:solidFill>
              <a:srgbClr val="FF6D4B"/>
            </a:solidFill>
            <a:ln>
              <a:solidFill>
                <a:srgbClr val="FF6D4B"/>
              </a:solidFill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579"/>
          <a:stretch/>
        </p:blipFill>
        <p:spPr>
          <a:xfrm>
            <a:off x="2922421" y="1458639"/>
            <a:ext cx="2790780" cy="2250506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695"/>
          <a:stretch/>
        </p:blipFill>
        <p:spPr>
          <a:xfrm>
            <a:off x="35175" y="1458639"/>
            <a:ext cx="2864379" cy="2250506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3322864" y="1161171"/>
            <a:ext cx="2330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rotein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1475771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450" y="982906"/>
            <a:ext cx="2883877" cy="253620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1591252" y="3028159"/>
            <a:ext cx="168627" cy="120077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11938" y="661290"/>
            <a:ext cx="16089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Chang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630003" y="717957"/>
            <a:ext cx="70969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Outcome</a:t>
            </a:r>
          </a:p>
          <a:p>
            <a:r>
              <a:rPr lang="en-US" sz="1000" dirty="0"/>
              <a:t>        PR</a:t>
            </a:r>
          </a:p>
          <a:p>
            <a:r>
              <a:rPr lang="en-US" sz="1000" dirty="0"/>
              <a:t>        SD</a:t>
            </a:r>
          </a:p>
          <a:p>
            <a:r>
              <a:rPr lang="en-US" sz="1000" dirty="0"/>
              <a:t>        P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594833" y="1520237"/>
            <a:ext cx="15002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ancer Type</a:t>
            </a:r>
          </a:p>
          <a:p>
            <a:r>
              <a:rPr lang="en-US" sz="1000" dirty="0"/>
              <a:t>        Endometrial</a:t>
            </a:r>
          </a:p>
          <a:p>
            <a:r>
              <a:rPr lang="en-US" sz="1000" dirty="0"/>
              <a:t>        Ovarian</a:t>
            </a:r>
          </a:p>
          <a:p>
            <a:r>
              <a:rPr lang="en-US" sz="1000" dirty="0"/>
              <a:t>        Breast</a:t>
            </a:r>
          </a:p>
        </p:txBody>
      </p:sp>
      <p:sp>
        <p:nvSpPr>
          <p:cNvPr id="8" name="Rectangle 7"/>
          <p:cNvSpPr/>
          <p:nvPr/>
        </p:nvSpPr>
        <p:spPr>
          <a:xfrm>
            <a:off x="3784004" y="948962"/>
            <a:ext cx="82220" cy="8222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3784004" y="1104932"/>
            <a:ext cx="82220" cy="82220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3784004" y="1260902"/>
            <a:ext cx="82220" cy="82220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771976" y="1733657"/>
            <a:ext cx="82220" cy="8222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3771976" y="1889627"/>
            <a:ext cx="82220" cy="82220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3771976" y="2045597"/>
            <a:ext cx="82220" cy="82220"/>
          </a:xfrm>
          <a:prstGeom prst="rect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9346897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180" y="1830344"/>
            <a:ext cx="4862540" cy="191028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07855" y="3285081"/>
            <a:ext cx="853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ecreased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814587" y="3285081"/>
            <a:ext cx="8408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Increased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26652292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2377387" y="6878049"/>
            <a:ext cx="118231" cy="2021479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761" y="1063261"/>
            <a:ext cx="3800546" cy="309248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087" y="4761645"/>
            <a:ext cx="3800547" cy="307896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091635" y="1072458"/>
            <a:ext cx="70969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Outcome</a:t>
            </a:r>
          </a:p>
          <a:p>
            <a:r>
              <a:rPr lang="en-US" sz="1000" dirty="0"/>
              <a:t>        PR</a:t>
            </a:r>
          </a:p>
          <a:p>
            <a:r>
              <a:rPr lang="en-US" sz="1000" dirty="0"/>
              <a:t>        SD</a:t>
            </a:r>
          </a:p>
          <a:p>
            <a:r>
              <a:rPr lang="en-US" sz="1000" dirty="0"/>
              <a:t>        P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056465" y="1874738"/>
            <a:ext cx="150027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/>
              <a:t>Cancer Type</a:t>
            </a:r>
          </a:p>
          <a:p>
            <a:r>
              <a:rPr lang="en-US" sz="1000" dirty="0"/>
              <a:t>        Endometrial</a:t>
            </a:r>
          </a:p>
          <a:p>
            <a:r>
              <a:rPr lang="en-US" sz="1000" dirty="0"/>
              <a:t>        Ovarian</a:t>
            </a:r>
          </a:p>
          <a:p>
            <a:r>
              <a:rPr lang="en-US" sz="1000" dirty="0"/>
              <a:t>        Breast</a:t>
            </a:r>
          </a:p>
        </p:txBody>
      </p:sp>
      <p:sp>
        <p:nvSpPr>
          <p:cNvPr id="8" name="Rectangle 7"/>
          <p:cNvSpPr/>
          <p:nvPr/>
        </p:nvSpPr>
        <p:spPr>
          <a:xfrm>
            <a:off x="4245636" y="1303463"/>
            <a:ext cx="82220" cy="82220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245636" y="1459433"/>
            <a:ext cx="82220" cy="82220"/>
          </a:xfrm>
          <a:prstGeom prst="rect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4245636" y="1615403"/>
            <a:ext cx="82220" cy="82220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233608" y="2088158"/>
            <a:ext cx="82220" cy="82220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4233608" y="2244128"/>
            <a:ext cx="82220" cy="82220"/>
          </a:xfrm>
          <a:prstGeom prst="rect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4233608" y="2400098"/>
            <a:ext cx="82220" cy="82220"/>
          </a:xfrm>
          <a:prstGeom prst="rect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233413" y="806773"/>
            <a:ext cx="9396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33413" y="4384028"/>
            <a:ext cx="9396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655182" y="848637"/>
            <a:ext cx="16089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re-treatment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643153" y="4557294"/>
            <a:ext cx="16089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ost-treatment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2373694" y="3206817"/>
            <a:ext cx="118795" cy="2020164"/>
          </a:xfrm>
          <a:prstGeom prst="rect">
            <a:avLst/>
          </a:prstGeom>
        </p:spPr>
      </p:pic>
      <p:sp>
        <p:nvSpPr>
          <p:cNvPr id="22" name="Left Bracket 21"/>
          <p:cNvSpPr/>
          <p:nvPr/>
        </p:nvSpPr>
        <p:spPr>
          <a:xfrm rot="16200000">
            <a:off x="2854928" y="3826237"/>
            <a:ext cx="66367" cy="100584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eft Bracket 22"/>
          <p:cNvSpPr/>
          <p:nvPr/>
        </p:nvSpPr>
        <p:spPr>
          <a:xfrm rot="16200000">
            <a:off x="1852721" y="3873601"/>
            <a:ext cx="66367" cy="9144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/>
          <p:cNvCxnSpPr/>
          <p:nvPr/>
        </p:nvCxnSpPr>
        <p:spPr>
          <a:xfrm flipV="1">
            <a:off x="1417138" y="1084692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2353113" y="1084692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 flipV="1">
            <a:off x="3440389" y="1084132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Left Bracket 33"/>
          <p:cNvSpPr/>
          <p:nvPr/>
        </p:nvSpPr>
        <p:spPr>
          <a:xfrm rot="16200000">
            <a:off x="3003708" y="7603462"/>
            <a:ext cx="66367" cy="812565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Left Bracket 34"/>
          <p:cNvSpPr/>
          <p:nvPr/>
        </p:nvSpPr>
        <p:spPr>
          <a:xfrm rot="16200000">
            <a:off x="2335849" y="7813499"/>
            <a:ext cx="66367" cy="395781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2171141" y="476528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 flipV="1">
            <a:off x="2560105" y="476528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 flipV="1">
            <a:off x="2630609" y="476472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 flipV="1">
            <a:off x="3446073" y="4764721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 flipV="1">
            <a:off x="1561532" y="4773237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Left Bracket 41"/>
          <p:cNvSpPr/>
          <p:nvPr/>
        </p:nvSpPr>
        <p:spPr>
          <a:xfrm rot="16200000">
            <a:off x="1835300" y="7714646"/>
            <a:ext cx="66367" cy="60531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1612721" y="8005426"/>
            <a:ext cx="565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CL1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077378" y="8012849"/>
            <a:ext cx="565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CL2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754044" y="8012848"/>
            <a:ext cx="5656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CL3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417138" y="4318183"/>
            <a:ext cx="9800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L1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591652" y="4318182"/>
            <a:ext cx="5656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CL2</a:t>
            </a:r>
          </a:p>
        </p:txBody>
      </p:sp>
      <p:cxnSp>
        <p:nvCxnSpPr>
          <p:cNvPr id="45" name="Straight Connector 44"/>
          <p:cNvCxnSpPr/>
          <p:nvPr/>
        </p:nvCxnSpPr>
        <p:spPr>
          <a:xfrm flipV="1">
            <a:off x="1819713" y="1110092"/>
            <a:ext cx="0" cy="320040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5</a:t>
            </a:r>
          </a:p>
        </p:txBody>
      </p:sp>
    </p:spTree>
    <p:extLst>
      <p:ext uri="{BB962C8B-B14F-4D97-AF65-F5344CB8AC3E}">
        <p14:creationId xmlns:p14="http://schemas.microsoft.com/office/powerpoint/2010/main" val="12417981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6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491" y="976746"/>
            <a:ext cx="1828800" cy="18288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73" y="976746"/>
            <a:ext cx="1828800" cy="18288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0655" y="976746"/>
            <a:ext cx="1828800" cy="18288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0655" y="3084734"/>
            <a:ext cx="1828800" cy="18288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0073" y="3084734"/>
            <a:ext cx="1828800" cy="18288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706" y="3083858"/>
            <a:ext cx="1828800" cy="18288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51004" y="798664"/>
            <a:ext cx="1759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I3K Pre-Treatment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640810" y="798664"/>
            <a:ext cx="190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I3K On-Treatment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019497" y="798664"/>
            <a:ext cx="1759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I3K Change (increases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51004" y="2857573"/>
            <a:ext cx="1759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Immune Pre-Treatment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667666" y="2837637"/>
            <a:ext cx="19006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RTK-MAPK cycle On-Treatment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05589" y="3326799"/>
            <a:ext cx="998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 = 0.07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019497" y="2837637"/>
            <a:ext cx="17597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RTK-MAPK Change (increase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679233" y="3326799"/>
            <a:ext cx="9980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p = 0.0026</a:t>
            </a:r>
          </a:p>
        </p:txBody>
      </p:sp>
    </p:spTree>
    <p:extLst>
      <p:ext uri="{BB962C8B-B14F-4D97-AF65-F5344CB8AC3E}">
        <p14:creationId xmlns:p14="http://schemas.microsoft.com/office/powerpoint/2010/main" val="28464736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-2" t="45284" r="-5989" b="-1"/>
          <a:stretch/>
        </p:blipFill>
        <p:spPr>
          <a:xfrm rot="16200000">
            <a:off x="2514645" y="2279131"/>
            <a:ext cx="96915" cy="96028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49716" y="1454044"/>
            <a:ext cx="13767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Pathway Activity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354"/>
          <a:stretch/>
        </p:blipFill>
        <p:spPr>
          <a:xfrm>
            <a:off x="1099573" y="1728215"/>
            <a:ext cx="2912287" cy="95926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103" y="1474030"/>
            <a:ext cx="387777" cy="605477"/>
          </a:xfrm>
          <a:prstGeom prst="rect">
            <a:avLst/>
          </a:prstGeom>
        </p:spPr>
      </p:pic>
      <p:grpSp>
        <p:nvGrpSpPr>
          <p:cNvPr id="11" name="Group 10"/>
          <p:cNvGrpSpPr/>
          <p:nvPr/>
        </p:nvGrpSpPr>
        <p:grpSpPr>
          <a:xfrm>
            <a:off x="435920" y="2117368"/>
            <a:ext cx="1192614" cy="861774"/>
            <a:chOff x="5786863" y="4789728"/>
            <a:chExt cx="1192614" cy="861774"/>
          </a:xfrm>
        </p:grpSpPr>
        <p:sp>
          <p:nvSpPr>
            <p:cNvPr id="12" name="TextBox 11"/>
            <p:cNvSpPr txBox="1"/>
            <p:nvPr/>
          </p:nvSpPr>
          <p:spPr>
            <a:xfrm>
              <a:off x="5786863" y="4789728"/>
              <a:ext cx="1192614" cy="86177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Treatment</a:t>
              </a:r>
            </a:p>
            <a:p>
              <a:r>
                <a:rPr lang="en-US" sz="1000" dirty="0"/>
                <a:t>        Vehicle</a:t>
              </a:r>
            </a:p>
            <a:p>
              <a:r>
                <a:rPr lang="en-US" sz="1000" dirty="0"/>
                <a:t>        PARP</a:t>
              </a:r>
            </a:p>
            <a:p>
              <a:r>
                <a:rPr lang="en-US" sz="1000" dirty="0"/>
                <a:t>        AKT</a:t>
              </a:r>
            </a:p>
            <a:p>
              <a:r>
                <a:rPr lang="en-US" sz="1000" dirty="0"/>
                <a:t>        Combination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940864" y="5020733"/>
              <a:ext cx="91440" cy="91440"/>
            </a:xfrm>
            <a:prstGeom prst="rect">
              <a:avLst/>
            </a:prstGeom>
            <a:solidFill>
              <a:schemeClr val="accent4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5940864" y="5176703"/>
              <a:ext cx="91440" cy="91440"/>
            </a:xfrm>
            <a:prstGeom prst="rect">
              <a:avLst/>
            </a:prstGeom>
            <a:solidFill>
              <a:schemeClr val="accent6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5940864" y="5332673"/>
              <a:ext cx="91440" cy="91440"/>
            </a:xfrm>
            <a:prstGeom prst="rect">
              <a:avLst/>
            </a:prstGeom>
            <a:solidFill>
              <a:schemeClr val="accent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5940864" y="5492292"/>
              <a:ext cx="91440" cy="91440"/>
            </a:xfrm>
            <a:prstGeom prst="rect">
              <a:avLst/>
            </a:prstGeom>
            <a:solidFill>
              <a:srgbClr val="7030A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66227" y="0"/>
            <a:ext cx="67917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3632426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90</TotalTime>
  <Words>108</Words>
  <Application>Microsoft Office PowerPoint</Application>
  <PresentationFormat>On-screen Show (4:3)</PresentationFormat>
  <Paragraphs>6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HS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lyne Labrie</dc:creator>
  <cp:lastModifiedBy>Marilyne Labrie</cp:lastModifiedBy>
  <cp:revision>104</cp:revision>
  <dcterms:created xsi:type="dcterms:W3CDTF">2020-07-08T16:39:25Z</dcterms:created>
  <dcterms:modified xsi:type="dcterms:W3CDTF">2020-12-16T18:27:43Z</dcterms:modified>
</cp:coreProperties>
</file>